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DB9F7F-7BB4-4C40-9B86-23FCD46B833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98DF7A-C1F0-4B2A-A2D7-4462C9B4B5C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ECBFAE-6E85-4C8F-828F-786666EDD8F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2463F3-D5E3-4547-9C3C-E4BFFCE1C52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830D2F-A7E0-45E0-B54E-205E56BDB94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F131DA-9D06-4D7F-850F-C0DA6285F69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903BB4-A493-46FC-8DCE-4503659EF66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C68993-8B5C-4A36-92A7-3F7D8EB8463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E1A762-D466-450A-860F-7B9587476C0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14D1F3-757B-49A8-BE9B-9D3BF0AE95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F1C222-98CA-40BB-8004-9B2839BFFA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CF1579-24B3-4FE3-85C8-AEE0FBE788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4CFB660-F9BF-472F-A5EC-B6D0E8F56CD4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uppo 12"/>
          <p:cNvGrpSpPr/>
          <p:nvPr/>
        </p:nvGrpSpPr>
        <p:grpSpPr>
          <a:xfrm>
            <a:off x="0" y="855720"/>
            <a:ext cx="7524720" cy="5931000"/>
            <a:chOff x="0" y="855720"/>
            <a:chExt cx="7524720" cy="5931000"/>
          </a:xfrm>
        </p:grpSpPr>
        <p:grpSp>
          <p:nvGrpSpPr>
            <p:cNvPr id="42" name="Gruppo 9"/>
            <p:cNvGrpSpPr/>
            <p:nvPr/>
          </p:nvGrpSpPr>
          <p:grpSpPr>
            <a:xfrm>
              <a:off x="0" y="855720"/>
              <a:ext cx="7524720" cy="5931000"/>
              <a:chOff x="0" y="855720"/>
              <a:chExt cx="7524720" cy="5931000"/>
            </a:xfrm>
          </p:grpSpPr>
          <p:pic>
            <p:nvPicPr>
              <p:cNvPr id="43" name="Immagine 3" descr="OUTPUT_giusto1.jpg"/>
              <p:cNvPicPr/>
              <p:nvPr/>
            </p:nvPicPr>
            <p:blipFill>
              <a:blip r:embed="rId1"/>
              <a:srcRect l="0" t="0" r="17713" b="0"/>
              <a:stretch/>
            </p:blipFill>
            <p:spPr>
              <a:xfrm>
                <a:off x="0" y="855720"/>
                <a:ext cx="7524720" cy="59310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4" name="Connettore 1 6"/>
              <p:cNvSpPr/>
              <p:nvPr/>
            </p:nvSpPr>
            <p:spPr>
              <a:xfrm>
                <a:off x="612720" y="3905280"/>
                <a:ext cx="6228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Connettore 1 8"/>
              <p:cNvSpPr/>
              <p:nvPr/>
            </p:nvSpPr>
            <p:spPr>
              <a:xfrm flipV="1">
                <a:off x="3746520" y="906480"/>
                <a:ext cx="0" cy="5507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46" name="Rettangolo 10"/>
            <p:cNvSpPr/>
            <p:nvPr/>
          </p:nvSpPr>
          <p:spPr>
            <a:xfrm>
              <a:off x="3971880" y="6556680"/>
              <a:ext cx="649080" cy="144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Rettangolo 11"/>
            <p:cNvSpPr/>
            <p:nvPr/>
          </p:nvSpPr>
          <p:spPr>
            <a:xfrm rot="16200000">
              <a:off x="-144720" y="3028680"/>
              <a:ext cx="647640" cy="142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"/>
          <p:cNvGraphicFramePr/>
          <p:nvPr/>
        </p:nvGraphicFramePr>
        <p:xfrm>
          <a:off x="1214280" y="500040"/>
          <a:ext cx="7423200" cy="4880160"/>
        </p:xfrm>
        <a:graphic>
          <a:graphicData uri="http://schemas.openxmlformats.org/drawingml/2006/table">
            <a:tbl>
              <a:tblPr/>
              <a:tblGrid>
                <a:gridCol w="1086120"/>
                <a:gridCol w="874440"/>
                <a:gridCol w="874800"/>
                <a:gridCol w="876240"/>
                <a:gridCol w="874800"/>
                <a:gridCol w="876240"/>
                <a:gridCol w="874800"/>
                <a:gridCol w="1085760"/>
              </a:tblGrid>
              <a:tr h="239760">
                <a:tc gridSpan="7">
                  <a:txBody>
                    <a:bodyPr lIns="9000" rIns="9000" tIns="9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900" spc="-1" strike="noStrike">
                          <a:solidFill>
                            <a:srgbClr val="000000"/>
                          </a:solidFill>
                          <a:latin typeface="Arial Bold"/>
                        </a:rPr>
                        <a:t>Rotated Component Matri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9760">
                <a:tc rowSpan="2">
                  <a:txBody>
                    <a:bodyPr lIns="9000" rIns="9000" tIns="90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93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 gridSpan="6"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omponen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93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98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93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288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0160">
                <a:tc>
                  <a:txBody>
                    <a:bodyPr lIns="9000" rIns="9000" tIns="900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H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" marR="9000">
                    <a:lnL w="93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09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93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.01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0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19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71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32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0160">
                <a:tc>
                  <a:txBody>
                    <a:bodyPr lIns="9000" rIns="9000" tIns="900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H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" marR="9000">
                    <a:lnL w="93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.00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93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.04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.06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.10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75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.06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9800">
                <a:tc>
                  <a:txBody>
                    <a:bodyPr lIns="9000" rIns="9000" tIns="900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" marR="9000">
                    <a:lnL w="93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55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93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.0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04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07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12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41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0160">
                <a:tc>
                  <a:txBody>
                    <a:bodyPr lIns="9000" rIns="9000" tIns="900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" marR="9000">
                    <a:lnL w="93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.09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93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.10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.07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.02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41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66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0160">
                <a:tc>
                  <a:txBody>
                    <a:bodyPr lIns="9000" rIns="9000" tIns="900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" marR="9000">
                    <a:lnL w="93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03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93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06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98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.0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.01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02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9800">
                <a:tc>
                  <a:txBody>
                    <a:bodyPr lIns="9000" rIns="9000" tIns="900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L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" marR="9000">
                    <a:lnL w="93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04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93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08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98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03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.05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0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0160">
                <a:tc>
                  <a:txBody>
                    <a:bodyPr lIns="9000" rIns="9000" tIns="900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" marR="9000">
                    <a:lnL w="93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.00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93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81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16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.28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07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.35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9800">
                <a:tc>
                  <a:txBody>
                    <a:bodyPr lIns="9000" rIns="9000" tIns="900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" marR="9000">
                    <a:lnL w="93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81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93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44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04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19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01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.02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0160">
                <a:tc>
                  <a:txBody>
                    <a:bodyPr lIns="9000" rIns="9000" tIns="900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" marR="9000">
                    <a:lnL w="93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82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93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04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07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26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.06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0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0160">
                <a:tc>
                  <a:txBody>
                    <a:bodyPr lIns="9000" rIns="9000" tIns="900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" marR="9000">
                    <a:lnL w="93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.7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93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4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.00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.09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.09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23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9800">
                <a:tc>
                  <a:txBody>
                    <a:bodyPr lIns="9000" rIns="9000" tIns="900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" marR="9000">
                    <a:lnL w="93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9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93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11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.02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17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09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04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0160">
                <a:tc>
                  <a:txBody>
                    <a:bodyPr lIns="9000" rIns="9000" tIns="900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" marR="9000">
                    <a:lnL w="93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02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93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8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07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07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.44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.09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0160">
                <a:tc>
                  <a:txBody>
                    <a:bodyPr lIns="9000" rIns="9000" tIns="900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UF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" marR="9000">
                    <a:lnL w="93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1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93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28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.1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14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18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.54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9800">
                <a:tc>
                  <a:txBody>
                    <a:bodyPr lIns="9000" rIns="9000" tIns="900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" marR="9000">
                    <a:lnL w="93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.64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93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36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13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.39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04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.31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0160">
                <a:tc>
                  <a:txBody>
                    <a:bodyPr lIns="9000" rIns="9000" tIns="900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W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" marR="9000">
                    <a:lnL w="93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67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93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63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02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04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09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.03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9800">
                <a:tc>
                  <a:txBody>
                    <a:bodyPr lIns="9000" rIns="9000" tIns="900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" marR="9000">
                    <a:lnL w="93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.56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93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19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.08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11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.55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25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0160">
                <a:tc>
                  <a:txBody>
                    <a:bodyPr lIns="9000" rIns="9000" tIns="900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SL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" marR="9000">
                    <a:lnL w="93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.22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93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0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.0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.89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02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06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0160">
                <a:tc>
                  <a:txBody>
                    <a:bodyPr lIns="9000" rIns="9000" tIns="900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S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" marR="9000">
                    <a:lnL w="93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72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93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03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04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16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0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.2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9800">
                <a:tc>
                  <a:txBody>
                    <a:bodyPr lIns="9000" rIns="9000" tIns="900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P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" marR="9000">
                    <a:lnL w="93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39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93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.09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02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84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01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.04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0160">
                <a:tc>
                  <a:txBody>
                    <a:bodyPr lIns="9000" rIns="9000" tIns="90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0160">
                <a:tc>
                  <a:txBody>
                    <a:bodyPr lIns="9000" rIns="9000" tIns="90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" rIns="9000" tIns="90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" marR="9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3-09T15:44:42Z</dcterms:created>
  <dc:creator>adriana sacco</dc:creator>
  <dc:description/>
  <dc:language>en-US</dc:language>
  <cp:lastModifiedBy>adriana</cp:lastModifiedBy>
  <dcterms:modified xsi:type="dcterms:W3CDTF">2015-07-28T20:00:15Z</dcterms:modified>
  <cp:revision>5</cp:revision>
  <dc:subject/>
  <dc:title>Diapositiva 1</dc:title>
</cp:coreProperties>
</file>